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032" y="6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B0EDAB-9F48-4B05-C732-61BB8E1A2F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FA32AD-025F-8740-4154-5B6CDFD707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3944DC-F547-07B0-843D-CE00830EC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10424-87EB-14DF-A9BC-9A2164DAA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DEE21D-6287-910D-5D77-F1D427E78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931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D4CDC1-CC02-0598-FC38-2C85379DF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EF164C-7556-BF90-1575-3A40C8A666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23BBD7-936B-778E-DA3F-BE520C636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795B38-2B55-A12C-89CE-72A9643AA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881F41-7CC3-29E1-76D7-0BAAF07BC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668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5FACE8-B191-2862-AAD1-428410E5E8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27CB6-9699-2A75-CD0B-1D2F81EF42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1EA389-54D6-0985-B811-330DC214E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646A3A-8383-F8A4-4ED9-C80D6024E6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922E94-CD48-2C9C-FDE2-AA8B1E503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735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6DF6B2-204B-08FA-E569-9E47F4A605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313F60-C8A9-6245-A500-DE09D1A892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41AADB-24DD-B89E-7661-1164B838A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93AEB1-67CC-52F4-6BB0-E6989AA96E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5DD4CA-B21F-7D43-99E0-C63EB23E2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259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D38E4F-3F6E-B2F5-89D8-3CB0E93521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3A8F15-392E-CC82-5237-59908AB769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4683DE-9C4E-3E18-DEC3-D66945797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C49EC4-8572-A90C-2E06-7D5CDE986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AC764C-7CA4-AE2B-34E4-0E4B5B0D4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686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034FA6-D6A0-FE9B-856C-70B1C7536B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C6A67B-93AF-1CB9-D996-83E75C74E5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48D064-874A-7973-C6CC-15224CA76D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30A50C-ED1A-0B1C-81FF-79DCFC3F9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1C43F9-C353-E067-8192-B84CCDA21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F7570F-6350-5A43-AE24-78D23F96E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330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4E5FA-7CB0-72CC-5E96-81691B5ED7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6D44BF-401B-E1C9-6108-1F7B4D142B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34AAB3-DFBC-9A3A-0956-CAE39DC81C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431C9E-0DA8-7EFA-97E8-00D3128B90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17B807-CF97-52C4-26BC-954120BB13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B71AC3-224C-3799-9740-FB2AB104B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A9C0F5-9DD3-E847-3260-287CD17A3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C01DA1-CF6D-193A-287D-81F12ED54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546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648527-C22D-D50B-8518-4A6AE4A9A5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46776F-B00B-A792-F97D-F0F34B27C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70FE56E-8B11-019F-C2FA-901511674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623C04-9100-D58B-5797-6CC548900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250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B8166C-77CF-B7AA-6E81-969EA84C3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08C828-317C-0D60-175B-00F89E90E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E73AAEE-2067-1921-62B4-95C180394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204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450282-490E-D2BD-5E89-0CB2B66FE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8CFFC9-4B15-AD0A-F778-A0F0EB13FB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F70BE2-A58B-55CF-F7D6-923D51E993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D1DAB8-954E-39B9-DCA7-871D1DBAE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B5BEA6-B70E-F9AE-E28E-52D747B13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2E0BB2-E095-D88E-6238-0A5B8D1EB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296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64FA99-6825-42BF-8E4F-5F0A9EC75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F7DB832-0E20-79C4-959B-1C3AF11E73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D022CF-F29E-7A44-3604-493F2DCA69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2C00D1-3554-0A35-A40D-7D166A6C1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B3A7C5-CA81-5CC7-E5C3-CD610FE2E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8FE8CD-5AB8-CFCA-F6FB-46F859EAA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372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EA5A86-C39A-03B6-4840-E231A2723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BB8BF1-5B44-EA33-01B3-8AEDF48811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95A55-F141-D332-CB79-755E35FF2C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A7E35A-4CDE-427E-AC38-CCA19E89AAD2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56E2E7-C658-DDBD-BACF-3CDB12C51E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120B82-29D2-58FF-AF0B-56E1AB9EB5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BA5D09E-3D34-432D-852F-BB7B816620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27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BE1736-4BFC-772C-360C-B5415765D9C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3625429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79DE7-D95B-78D9-3375-CC00A459EA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Table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25DD448-1E6B-B558-A108-DF9E941874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6511" y="2509520"/>
            <a:ext cx="6567889" cy="1865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14914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BFC774-EA68-B009-1E4D-4B4C1ECBE5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1</a:t>
            </a:r>
          </a:p>
        </p:txBody>
      </p:sp>
      <p:pic>
        <p:nvPicPr>
          <p:cNvPr id="4" name="image52.png">
            <a:extLst>
              <a:ext uri="{FF2B5EF4-FFF2-40B4-BE49-F238E27FC236}">
                <a16:creationId xmlns:a16="http://schemas.microsoft.com/office/drawing/2014/main" id="{78592AE0-9F93-75E3-3804-8B85786EA08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116" t="11529" r="50214" b="34202"/>
          <a:stretch>
            <a:fillRect/>
          </a:stretch>
        </p:blipFill>
        <p:spPr>
          <a:xfrm>
            <a:off x="1195916" y="2335740"/>
            <a:ext cx="3985683" cy="2593323"/>
          </a:xfrm>
          <a:prstGeom prst="rect">
            <a:avLst/>
          </a:prstGeom>
          <a:ln w="12700">
            <a:miter lim="400000"/>
          </a:ln>
        </p:spPr>
      </p:pic>
      <p:pic>
        <p:nvPicPr>
          <p:cNvPr id="3" name="image52.png">
            <a:extLst>
              <a:ext uri="{FF2B5EF4-FFF2-40B4-BE49-F238E27FC236}">
                <a16:creationId xmlns:a16="http://schemas.microsoft.com/office/drawing/2014/main" id="{99300664-AFA5-674F-8D3A-3DCFB332924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4333" t="10535" r="1418" b="36096"/>
          <a:stretch>
            <a:fillRect/>
          </a:stretch>
        </p:blipFill>
        <p:spPr>
          <a:xfrm>
            <a:off x="5585883" y="2337924"/>
            <a:ext cx="3796242" cy="2671569"/>
          </a:xfrm>
          <a:prstGeom prst="rect">
            <a:avLst/>
          </a:prstGeom>
          <a:ln w="12700">
            <a:miter lim="400000"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F8B6ED6-CC23-D997-41D9-FBB60CD1CD6F}"/>
              </a:ext>
            </a:extLst>
          </p:cNvPr>
          <p:cNvSpPr txBox="1"/>
          <p:nvPr/>
        </p:nvSpPr>
        <p:spPr>
          <a:xfrm>
            <a:off x="1179871" y="1769806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193B33-E7C3-567F-136F-593CA1AA1C08}"/>
              </a:ext>
            </a:extLst>
          </p:cNvPr>
          <p:cNvSpPr txBox="1"/>
          <p:nvPr/>
        </p:nvSpPr>
        <p:spPr>
          <a:xfrm>
            <a:off x="5766633" y="178455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510469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E8726B-E24F-BBF4-A9FB-BBA24EA7A1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2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7BE300B-7BB6-A732-C7A5-40546348C7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397571"/>
              </p:ext>
            </p:extLst>
          </p:nvPr>
        </p:nvGraphicFramePr>
        <p:xfrm>
          <a:off x="1340332" y="1939925"/>
          <a:ext cx="4041775" cy="4632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628746" imgH="3014319" progId="Prism9.Document">
                  <p:embed/>
                </p:oleObj>
              </mc:Choice>
              <mc:Fallback>
                <p:oleObj name="Prism 9" r:id="rId2" imgW="2628746" imgH="3014319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98EE95C-B284-5991-F29B-A229ED1838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40332" y="1939925"/>
                        <a:ext cx="4041775" cy="4632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5854FB2-8C73-D297-E870-969C42BE07C7}"/>
              </a:ext>
            </a:extLst>
          </p:cNvPr>
          <p:cNvSpPr txBox="1"/>
          <p:nvPr/>
        </p:nvSpPr>
        <p:spPr>
          <a:xfrm>
            <a:off x="1179871" y="1769806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B1BA5D5-FCCE-4B0B-A13D-318BCA88F8F7}"/>
              </a:ext>
            </a:extLst>
          </p:cNvPr>
          <p:cNvSpPr txBox="1"/>
          <p:nvPr/>
        </p:nvSpPr>
        <p:spPr>
          <a:xfrm>
            <a:off x="5766633" y="178455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14F456D-9554-2649-4BD2-10930852CD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6561216"/>
              </p:ext>
            </p:extLst>
          </p:nvPr>
        </p:nvGraphicFramePr>
        <p:xfrm>
          <a:off x="6140450" y="2024063"/>
          <a:ext cx="4324350" cy="446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7664867" imgH="7911596" progId="Prism9.Document">
                  <p:embed/>
                </p:oleObj>
              </mc:Choice>
              <mc:Fallback>
                <p:oleObj name="Prism 9" r:id="rId4" imgW="7664867" imgH="7911596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91CDA11-E51F-4F75-206C-647EF019CC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40450" y="2024063"/>
                        <a:ext cx="4324350" cy="4464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241719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632987-1F8D-3B55-AF65-A40CD19B31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362F134-C153-586F-8E5D-004840E077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6810125"/>
              </p:ext>
            </p:extLst>
          </p:nvPr>
        </p:nvGraphicFramePr>
        <p:xfrm>
          <a:off x="472551" y="2508027"/>
          <a:ext cx="5532643" cy="28402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889165" imgH="3536983" progId="Prism9.Document">
                  <p:embed/>
                </p:oleObj>
              </mc:Choice>
              <mc:Fallback>
                <p:oleObj name="Prism 9" r:id="rId2" imgW="6889165" imgH="353698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2551" y="2508027"/>
                        <a:ext cx="5532643" cy="28402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3CF7E84-6CCE-1DA3-5875-386A46E177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6606512"/>
              </p:ext>
            </p:extLst>
          </p:nvPr>
        </p:nvGraphicFramePr>
        <p:xfrm>
          <a:off x="6207760" y="2508028"/>
          <a:ext cx="5815648" cy="28402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7242640" imgH="3536983" progId="Prism9.Document">
                  <p:embed/>
                </p:oleObj>
              </mc:Choice>
              <mc:Fallback>
                <p:oleObj name="Prism 9" r:id="rId4" imgW="7242640" imgH="353698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07760" y="2508028"/>
                        <a:ext cx="5815648" cy="28402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46FADFA-D831-513A-B96B-805B5795F12D}"/>
              </a:ext>
            </a:extLst>
          </p:cNvPr>
          <p:cNvSpPr txBox="1"/>
          <p:nvPr/>
        </p:nvSpPr>
        <p:spPr>
          <a:xfrm>
            <a:off x="589280" y="2082800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7CB1961-353E-A051-9CFA-531D4C43BA99}"/>
              </a:ext>
            </a:extLst>
          </p:cNvPr>
          <p:cNvSpPr txBox="1"/>
          <p:nvPr/>
        </p:nvSpPr>
        <p:spPr>
          <a:xfrm>
            <a:off x="6400800" y="209296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976152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36</TotalTime>
  <Words>20</Words>
  <Application>Microsoft Office PowerPoint</Application>
  <PresentationFormat>Widescreen</PresentationFormat>
  <Paragraphs>11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rism 9</vt:lpstr>
      <vt:lpstr>Supplementary Material</vt:lpstr>
      <vt:lpstr>Supplementary Table 1</vt:lpstr>
      <vt:lpstr>Supplementary Figure 1</vt:lpstr>
      <vt:lpstr>Supplementary Figure 2</vt:lpstr>
      <vt:lpstr>Supplementary Figure 3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eophilos Tzaridis</dc:creator>
  <cp:lastModifiedBy>Theophilos Tzaridis</cp:lastModifiedBy>
  <cp:revision>9</cp:revision>
  <dcterms:created xsi:type="dcterms:W3CDTF">2025-01-06T21:23:19Z</dcterms:created>
  <dcterms:modified xsi:type="dcterms:W3CDTF">2025-09-15T22:52:37Z</dcterms:modified>
</cp:coreProperties>
</file>